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4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blic\Documents\FAMRI%20Project%20Data\FAMRI%20Histology\Histology%20Data%20for%20Graphing%20-%20Athero%20article%20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ublic\Documents\FAMRI%20Project%20Data\FAMRI%20Histology\Histology%20Data%20for%20Graphing%20-%20Athero%20article%20201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Curvature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trix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7662943201181447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970110374817154"/>
          <c:y val="0.16714129483814524"/>
          <c:w val="0.84133604930508532"/>
          <c:h val="0.74002697579469234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9wks '!$B$60:$C$60</c:f>
                <c:numCache>
                  <c:formatCode>General</c:formatCode>
                  <c:ptCount val="2"/>
                  <c:pt idx="0">
                    <c:v>0.29755951785595208</c:v>
                  </c:pt>
                  <c:pt idx="1">
                    <c:v>0.23571428571428563</c:v>
                  </c:pt>
                </c:numCache>
              </c:numRef>
            </c:plus>
            <c:minus>
              <c:numRef>
                <c:f>'Movat 9wks '!$B$60:$C$60</c:f>
                <c:numCache>
                  <c:formatCode>General</c:formatCode>
                  <c:ptCount val="2"/>
                  <c:pt idx="0">
                    <c:v>0.29755951785595208</c:v>
                  </c:pt>
                  <c:pt idx="1">
                    <c:v>0.23571428571428563</c:v>
                  </c:pt>
                </c:numCache>
              </c:numRef>
            </c:minus>
          </c:errBars>
          <c:cat>
            <c:numRef>
              <c:f>'Movat 9wks '!$B$50:$C$5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cat>
          <c:val>
            <c:numRef>
              <c:f>'Movat 9wks '!$B$58:$C$58</c:f>
              <c:numCache>
                <c:formatCode>General</c:formatCode>
                <c:ptCount val="2"/>
                <c:pt idx="0">
                  <c:v>1.375</c:v>
                </c:pt>
                <c:pt idx="1">
                  <c:v>1.36071428571428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28224"/>
        <c:axId val="37030528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B$50,'Movat 9wks '!$D$49)</c:f>
              <c:numCache>
                <c:formatCode>General</c:formatCode>
                <c:ptCount val="2"/>
                <c:pt idx="0">
                  <c:v>1</c:v>
                </c:pt>
                <c:pt idx="1">
                  <c:v>2.02</c:v>
                </c:pt>
              </c:numCache>
            </c:numRef>
          </c:xVal>
          <c:yVal>
            <c:numRef>
              <c:f>'Movat 9wks '!$B$52:$C$52</c:f>
              <c:numCache>
                <c:formatCode>0.00</c:formatCode>
                <c:ptCount val="2"/>
                <c:pt idx="0">
                  <c:v>2.25</c:v>
                </c:pt>
                <c:pt idx="1">
                  <c:v>1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50:$C$5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53:$C$53</c:f>
              <c:numCache>
                <c:formatCode>General</c:formatCode>
                <c:ptCount val="2"/>
                <c:pt idx="0" formatCode="0.00">
                  <c:v>1.25</c:v>
                </c:pt>
                <c:pt idx="1">
                  <c:v>2.2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A$49,'Movat 9wks '!$C$49)</c:f>
              <c:numCache>
                <c:formatCode>General</c:formatCode>
                <c:ptCount val="2"/>
                <c:pt idx="0">
                  <c:v>0.98</c:v>
                </c:pt>
                <c:pt idx="1">
                  <c:v>1.98</c:v>
                </c:pt>
              </c:numCache>
            </c:numRef>
          </c:xVal>
          <c:yVal>
            <c:numRef>
              <c:f>'Movat 9wks '!$B$54:$C$54</c:f>
              <c:numCache>
                <c:formatCode>General</c:formatCode>
                <c:ptCount val="2"/>
                <c:pt idx="0" formatCode="0.00">
                  <c:v>1</c:v>
                </c:pt>
                <c:pt idx="1">
                  <c:v>1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9wks '!$B$49,'Movat 9wks '!$C$50)</c:f>
              <c:numCache>
                <c:formatCode>General</c:formatCode>
                <c:ptCount val="2"/>
                <c:pt idx="0">
                  <c:v>1.02</c:v>
                </c:pt>
                <c:pt idx="1">
                  <c:v>2</c:v>
                </c:pt>
              </c:numCache>
            </c:numRef>
          </c:xVal>
          <c:yVal>
            <c:numRef>
              <c:f>'Movat 9wks '!$B$55:$C$55</c:f>
              <c:numCache>
                <c:formatCode>0.00</c:formatCode>
                <c:ptCount val="2"/>
                <c:pt idx="0">
                  <c:v>1</c:v>
                </c:pt>
                <c:pt idx="1">
                  <c:v>1.4285714285714286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9wks '!$B$50:$C$5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56:$C$56</c:f>
              <c:numCache>
                <c:formatCode>0.00</c:formatCode>
                <c:ptCount val="2"/>
                <c:pt idx="1">
                  <c:v>1.125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9wks '!$B$50:$C$5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57:$C$57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28224"/>
        <c:axId val="37030528"/>
      </c:scatterChart>
      <c:catAx>
        <c:axId val="37028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7030528"/>
        <c:crosses val="autoZero"/>
        <c:auto val="1"/>
        <c:lblAlgn val="ctr"/>
        <c:lblOffset val="100"/>
        <c:noMultiLvlLbl val="0"/>
      </c:catAx>
      <c:valAx>
        <c:axId val="370305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32051108194808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7028224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 Curvature </a:t>
            </a:r>
          </a:p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llagen Density (Movat’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3948408878027738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4788557375989098"/>
          <c:y val="0.16714129483814524"/>
          <c:w val="0.82302625642005645"/>
          <c:h val="0.74002697579469234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9wks '!$B$45:$C$45</c:f>
                <c:numCache>
                  <c:formatCode>General</c:formatCode>
                  <c:ptCount val="2"/>
                  <c:pt idx="0">
                    <c:v>0.48277625942735281</c:v>
                  </c:pt>
                  <c:pt idx="1">
                    <c:v>0.17048699752922625</c:v>
                  </c:pt>
                </c:numCache>
              </c:numRef>
            </c:plus>
            <c:minus>
              <c:numRef>
                <c:f>'Movat 9wks '!$B$45:$C$45</c:f>
                <c:numCache>
                  <c:formatCode>General</c:formatCode>
                  <c:ptCount val="2"/>
                  <c:pt idx="0">
                    <c:v>0.48277625942735281</c:v>
                  </c:pt>
                  <c:pt idx="1">
                    <c:v>0.17048699752922625</c:v>
                  </c:pt>
                </c:numCache>
              </c:numRef>
            </c:minus>
          </c:errBars>
          <c:cat>
            <c:numRef>
              <c:f>'Movat 9wks '!$B$35:$C$35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cat>
          <c:val>
            <c:numRef>
              <c:f>'Movat 9wks '!$B$43:$C$43</c:f>
              <c:numCache>
                <c:formatCode>General</c:formatCode>
                <c:ptCount val="2"/>
                <c:pt idx="0">
                  <c:v>1.5625</c:v>
                </c:pt>
                <c:pt idx="1">
                  <c:v>1.955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113664"/>
        <c:axId val="38115968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c:spPr>
          </c:marker>
          <c:xVal>
            <c:numRef>
              <c:f>'Movat 9wks '!$B$35:$C$35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37:$C$37</c:f>
              <c:numCache>
                <c:formatCode>0.00</c:formatCode>
                <c:ptCount val="2"/>
                <c:pt idx="0">
                  <c:v>3</c:v>
                </c:pt>
                <c:pt idx="1">
                  <c:v>1.8571428571428572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c:spPr>
          </c:marker>
          <c:xVal>
            <c:numRef>
              <c:f>('Movat 9wks '!$A$34,'Movat 9wks '!$C$35)</c:f>
              <c:numCache>
                <c:formatCode>General</c:formatCode>
                <c:ptCount val="2"/>
                <c:pt idx="0">
                  <c:v>0.98</c:v>
                </c:pt>
                <c:pt idx="1">
                  <c:v>2</c:v>
                </c:pt>
              </c:numCache>
            </c:numRef>
          </c:xVal>
          <c:yVal>
            <c:numRef>
              <c:f>'Movat 9wks '!$B$38:$C$38</c:f>
              <c:numCache>
                <c:formatCode>General</c:formatCode>
                <c:ptCount val="2"/>
                <c:pt idx="0" formatCode="0.00">
                  <c:v>1</c:v>
                </c:pt>
                <c:pt idx="1">
                  <c:v>2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c:spPr>
          </c:marker>
          <c:xVal>
            <c:numRef>
              <c:f>'Movat 9wks '!$B$35:$C$35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39:$C$39</c:f>
              <c:numCache>
                <c:formatCode>General</c:formatCode>
                <c:ptCount val="2"/>
                <c:pt idx="0" formatCode="0.00">
                  <c:v>1.25</c:v>
                </c:pt>
                <c:pt idx="1">
                  <c:v>2.4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c:spPr>
          </c:marker>
          <c:xVal>
            <c:numRef>
              <c:f>('Movat 9wks '!$B$34,'Movat 9wks '!$C$35)</c:f>
              <c:numCache>
                <c:formatCode>General</c:formatCode>
                <c:ptCount val="2"/>
                <c:pt idx="0">
                  <c:v>1.0249999999999999</c:v>
                </c:pt>
                <c:pt idx="1">
                  <c:v>2</c:v>
                </c:pt>
              </c:numCache>
            </c:numRef>
          </c:xVal>
          <c:yVal>
            <c:numRef>
              <c:f>'Movat 9wks '!$B$40:$C$40</c:f>
              <c:numCache>
                <c:formatCode>0.00</c:formatCode>
                <c:ptCount val="2"/>
                <c:pt idx="0">
                  <c:v>1</c:v>
                </c:pt>
                <c:pt idx="1">
                  <c:v>2.1428571428571428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c:spPr>
          </c:marker>
          <c:xVal>
            <c:numRef>
              <c:f>'Movat 9wks '!$B$35:$C$35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41:$C$41</c:f>
              <c:numCache>
                <c:formatCode>0.00</c:formatCode>
                <c:ptCount val="2"/>
                <c:pt idx="1">
                  <c:v>1.375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Movat 9wks '!$B$35:$C$35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Movat 9wks '!$B$42:$C$42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113664"/>
        <c:axId val="38115968"/>
      </c:scatterChart>
      <c:catAx>
        <c:axId val="38113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8115968"/>
        <c:crosses val="autoZero"/>
        <c:auto val="1"/>
        <c:lblAlgn val="ctr"/>
        <c:lblOffset val="100"/>
        <c:noMultiLvlLbl val="0"/>
      </c:catAx>
      <c:valAx>
        <c:axId val="38115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stological 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Score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927333041703120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8113664"/>
        <c:crosses val="autoZero"/>
        <c:crossBetween val="between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 Curvatur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Lesion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e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ORO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013404574428195"/>
          <c:y val="2.7777777777777776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7727666854143231"/>
          <c:y val="0.13936351706036745"/>
          <c:w val="0.8016345613048369"/>
          <c:h val="0.74465660542432199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9wk Treatment ORO Plaque Area'!$B$30:$C$30</c:f>
                <c:numCache>
                  <c:formatCode>General</c:formatCode>
                  <c:ptCount val="2"/>
                  <c:pt idx="0">
                    <c:v>3517.0876911729101</c:v>
                  </c:pt>
                  <c:pt idx="1">
                    <c:v>2015.6717125811942</c:v>
                  </c:pt>
                </c:numCache>
              </c:numRef>
            </c:plus>
            <c:minus>
              <c:numRef>
                <c:f>'9wk Treatment ORO Plaque Area'!$B$30:$C$30</c:f>
                <c:numCache>
                  <c:formatCode>General</c:formatCode>
                  <c:ptCount val="2"/>
                  <c:pt idx="0">
                    <c:v>3517.0876911729101</c:v>
                  </c:pt>
                  <c:pt idx="1">
                    <c:v>2015.6717125811942</c:v>
                  </c:pt>
                </c:numCache>
              </c:numRef>
            </c:minus>
          </c:errBars>
          <c:cat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cat>
          <c:val>
            <c:numRef>
              <c:f>'9wk Treatment ORO Plaque Area'!$B$28:$C$28</c:f>
              <c:numCache>
                <c:formatCode>General</c:formatCode>
                <c:ptCount val="2"/>
                <c:pt idx="0">
                  <c:v>15954.670000000002</c:v>
                </c:pt>
                <c:pt idx="1">
                  <c:v>10839.36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496128"/>
        <c:axId val="3849766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22:$C$22</c:f>
              <c:numCache>
                <c:formatCode>General</c:formatCode>
                <c:ptCount val="2"/>
                <c:pt idx="0">
                  <c:v>21169.5</c:v>
                </c:pt>
                <c:pt idx="1">
                  <c:v>12151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23:$C$23</c:f>
              <c:numCache>
                <c:formatCode>General</c:formatCode>
                <c:ptCount val="2"/>
                <c:pt idx="0">
                  <c:v>11610.25</c:v>
                </c:pt>
                <c:pt idx="1">
                  <c:v>7791.2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24:$C$24</c:f>
              <c:numCache>
                <c:formatCode>General</c:formatCode>
                <c:ptCount val="2"/>
                <c:pt idx="0">
                  <c:v>12797</c:v>
                </c:pt>
                <c:pt idx="1">
                  <c:v>4794.8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25:$C$25</c:f>
              <c:numCache>
                <c:formatCode>General</c:formatCode>
                <c:ptCount val="2"/>
                <c:pt idx="0">
                  <c:v>26812.799999999999</c:v>
                </c:pt>
                <c:pt idx="1">
                  <c:v>13418.8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26:$C$26</c:f>
              <c:numCache>
                <c:formatCode>General</c:formatCode>
                <c:ptCount val="2"/>
                <c:pt idx="0">
                  <c:v>7383.8</c:v>
                </c:pt>
                <c:pt idx="1">
                  <c:v>16041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9wk Treatment ORO Plaque Area'!$B$20:$C$20</c:f>
              <c:numCache>
                <c:formatCode>General</c:formatCode>
                <c:ptCount val="2"/>
                <c:pt idx="0">
                  <c:v>1</c:v>
                </c:pt>
                <c:pt idx="1">
                  <c:v>2</c:v>
                </c:pt>
              </c:numCache>
            </c:numRef>
          </c:xVal>
          <c:yVal>
            <c:numRef>
              <c:f>'9wk Treatment ORO Plaque Area'!$B$27:$C$27</c:f>
              <c:numCache>
                <c:formatCode>General</c:formatCode>
                <c:ptCount val="2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496128"/>
        <c:axId val="38497664"/>
      </c:scatterChart>
      <c:catAx>
        <c:axId val="38496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8497664"/>
        <c:crosses val="autoZero"/>
        <c:auto val="1"/>
        <c:lblAlgn val="ctr"/>
        <c:lblOffset val="100"/>
        <c:noMultiLvlLbl val="0"/>
      </c:catAx>
      <c:valAx>
        <c:axId val="384976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Lesion Area (</a:t>
                </a:r>
                <a:r>
                  <a:rPr lang="el-GR" dirty="0" smtClean="0"/>
                  <a:t>μ</a:t>
                </a:r>
                <a:r>
                  <a:rPr lang="en-US" dirty="0" smtClean="0"/>
                  <a:t>M²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"/>
              <c:y val="0.265013487897346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8496128"/>
        <c:crosses val="autoZero"/>
        <c:crossBetween val="between"/>
        <c:majorUnit val="1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457200" y="13252"/>
            <a:ext cx="8229600" cy="748748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8 Fig (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s 8C and 8D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Movat, ORO - Lesser Curvature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876800" y="3980967"/>
            <a:ext cx="4137991" cy="2901614"/>
            <a:chOff x="304800" y="1066800"/>
            <a:chExt cx="4137991" cy="2901614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527468"/>
                </p:ext>
              </p:extLst>
            </p:nvPr>
          </p:nvGraphicFramePr>
          <p:xfrm>
            <a:off x="304800" y="1066800"/>
            <a:ext cx="4137991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1025236" y="3537527"/>
              <a:ext cx="3200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WD + SHS            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Control                            Ly6G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533400" y="3965624"/>
            <a:ext cx="4144434" cy="2892376"/>
            <a:chOff x="4724400" y="1066800"/>
            <a:chExt cx="4144434" cy="2892376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37009009"/>
                </p:ext>
              </p:extLst>
            </p:nvPr>
          </p:nvGraphicFramePr>
          <p:xfrm>
            <a:off x="4724400" y="1066800"/>
            <a:ext cx="4144434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5486400" y="3528289"/>
              <a:ext cx="3200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WD + SHS            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Control                             Ly6G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2209800" y="914400"/>
            <a:ext cx="4267200" cy="2793087"/>
            <a:chOff x="2438400" y="3962400"/>
            <a:chExt cx="4267200" cy="2793087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553396"/>
                </p:ext>
              </p:extLst>
            </p:nvPr>
          </p:nvGraphicFramePr>
          <p:xfrm>
            <a:off x="2438400" y="3962400"/>
            <a:ext cx="42672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3308927" y="6324600"/>
              <a:ext cx="32004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WD + SHS                           WD + SHS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Control                            Ly6G:siMMP-9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2057400" y="781043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33400" y="3994666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876800" y="3994666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59087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9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8 Fig (Figs 8C and 8D Movat, ORO - Lesser Curvature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11</cp:revision>
  <dcterms:created xsi:type="dcterms:W3CDTF">2017-01-26T23:47:11Z</dcterms:created>
  <dcterms:modified xsi:type="dcterms:W3CDTF">2017-01-27T00:00:20Z</dcterms:modified>
</cp:coreProperties>
</file>